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968B1-89C6-4A54-8F8B-6E07944AA4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5953B-C158-41E2-8809-2F8FBD87E9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088AF-74B4-4697-9F0E-98F1020F93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8CA40-E707-4584-8D39-7229C90946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1168B-14E7-4C45-BB79-C1F749F178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28A0B-7AAA-4E0C-8EA7-110685EF7E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7AFAB-12F9-4C42-A92D-17C4151354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2A96C-6167-4787-8B96-58E2CE09A8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B2464-D841-4926-AE4B-81FBB55767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51462-233F-4423-AE1C-CC01E4A041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2C07D-CC5C-43F4-A026-2C5E3DE468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55B8B-DF83-41E0-AF80-25058EFE18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E5B8AD-D8A1-476A-A608-528A0E22272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5"/>
          <p:cNvGrpSpPr/>
          <p:nvPr/>
        </p:nvGrpSpPr>
        <p:grpSpPr>
          <a:xfrm>
            <a:off x="900000" y="762120"/>
            <a:ext cx="7239240" cy="3657600"/>
            <a:chOff x="900000" y="762120"/>
            <a:chExt cx="7239240" cy="3657600"/>
          </a:xfrm>
        </p:grpSpPr>
        <p:sp>
          <p:nvSpPr>
            <p:cNvPr id="42" name="Rectangle 14"/>
            <p:cNvSpPr/>
            <p:nvPr/>
          </p:nvSpPr>
          <p:spPr>
            <a:xfrm>
              <a:off x="900000" y="762120"/>
              <a:ext cx="7239240" cy="36576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13"/>
            <p:cNvGrpSpPr/>
            <p:nvPr/>
          </p:nvGrpSpPr>
          <p:grpSpPr>
            <a:xfrm>
              <a:off x="1294920" y="914400"/>
              <a:ext cx="6401160" cy="3124440"/>
              <a:chOff x="1294920" y="914400"/>
              <a:chExt cx="6401160" cy="3124440"/>
            </a:xfrm>
          </p:grpSpPr>
          <p:pic>
            <p:nvPicPr>
              <p:cNvPr id="44" name="Picture 2" descr="C:\Users\Gudiya\Desktop\Captured 1.jpg"/>
              <p:cNvPicPr/>
              <p:nvPr/>
            </p:nvPicPr>
            <p:blipFill>
              <a:blip r:embed="rId1">
                <a:lum bright="-4000"/>
              </a:blip>
              <a:srcRect l="0" t="13332" r="50890" b="46669"/>
              <a:stretch/>
            </p:blipFill>
            <p:spPr>
              <a:xfrm>
                <a:off x="1294920" y="1295280"/>
                <a:ext cx="2971800" cy="2743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2" descr="C:\Users\Gudiya\Desktop\TGB LMFM_6.5PH_GFP1.jpg"/>
              <p:cNvPicPr/>
              <p:nvPr/>
            </p:nvPicPr>
            <p:blipFill>
              <a:blip r:embed="rId2">
                <a:lum contrast="10000"/>
              </a:blip>
              <a:srcRect l="24446" t="45558" r="31113" b="14443"/>
              <a:stretch/>
            </p:blipFill>
            <p:spPr>
              <a:xfrm>
                <a:off x="4724280" y="1295280"/>
                <a:ext cx="2971800" cy="2743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Box 8"/>
              <p:cNvSpPr/>
              <p:nvPr/>
            </p:nvSpPr>
            <p:spPr>
              <a:xfrm>
                <a:off x="2130480" y="914400"/>
                <a:ext cx="1215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</a:rPr>
                  <a:t>μ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 curcum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9"/>
              <p:cNvSpPr/>
              <p:nvPr/>
            </p:nvSpPr>
            <p:spPr>
              <a:xfrm>
                <a:off x="5550840" y="914400"/>
                <a:ext cx="130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</a:rPr>
                  <a:t>μ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 curcum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8" name="TextBox 16"/>
          <p:cNvSpPr/>
          <p:nvPr/>
        </p:nvSpPr>
        <p:spPr>
          <a:xfrm>
            <a:off x="533520" y="4648320"/>
            <a:ext cx="8001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: Microscopic image of cells showing the effect of curcumin on htt72Q-GFP aggregates in yeas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3T10:59:00Z</dcterms:created>
  <dc:creator>Gudiya</dc:creator>
  <dc:description/>
  <dc:language>en-US</dc:language>
  <cp:lastModifiedBy>Gudiya</cp:lastModifiedBy>
  <dcterms:modified xsi:type="dcterms:W3CDTF">2012-07-18T06:22:20Z</dcterms:modified>
  <cp:revision>4</cp:revision>
  <dc:subject/>
  <dc:title>Slide 1</dc:title>
</cp:coreProperties>
</file>